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7" r:id="rId2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49"/>
    <p:restoredTop sz="94659"/>
  </p:normalViewPr>
  <p:slideViewPr>
    <p:cSldViewPr snapToGrid="0" snapToObjects="1">
      <p:cViewPr>
        <p:scale>
          <a:sx n="167" d="100"/>
          <a:sy n="167" d="100"/>
        </p:scale>
        <p:origin x="720" y="-16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F7934-A803-614D-B7D5-96394A326413}" type="datetimeFigureOut">
              <a:rPr lang="en-US" smtClean="0"/>
              <a:t>4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742BB-2BFA-E24E-82AE-288ADAB701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66057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F7934-A803-614D-B7D5-96394A326413}" type="datetimeFigureOut">
              <a:rPr lang="en-US" smtClean="0"/>
              <a:t>4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742BB-2BFA-E24E-82AE-288ADAB701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60087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F7934-A803-614D-B7D5-96394A326413}" type="datetimeFigureOut">
              <a:rPr lang="en-US" smtClean="0"/>
              <a:t>4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742BB-2BFA-E24E-82AE-288ADAB701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1613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F7934-A803-614D-B7D5-96394A326413}" type="datetimeFigureOut">
              <a:rPr lang="en-US" smtClean="0"/>
              <a:t>4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742BB-2BFA-E24E-82AE-288ADAB701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5193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F7934-A803-614D-B7D5-96394A326413}" type="datetimeFigureOut">
              <a:rPr lang="en-US" smtClean="0"/>
              <a:t>4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742BB-2BFA-E24E-82AE-288ADAB701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0316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F7934-A803-614D-B7D5-96394A326413}" type="datetimeFigureOut">
              <a:rPr lang="en-US" smtClean="0"/>
              <a:t>4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742BB-2BFA-E24E-82AE-288ADAB701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5131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F7934-A803-614D-B7D5-96394A326413}" type="datetimeFigureOut">
              <a:rPr lang="en-US" smtClean="0"/>
              <a:t>4/19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742BB-2BFA-E24E-82AE-288ADAB701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35078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F7934-A803-614D-B7D5-96394A326413}" type="datetimeFigureOut">
              <a:rPr lang="en-US" smtClean="0"/>
              <a:t>4/19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742BB-2BFA-E24E-82AE-288ADAB701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8278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F7934-A803-614D-B7D5-96394A326413}" type="datetimeFigureOut">
              <a:rPr lang="en-US" smtClean="0"/>
              <a:t>4/19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742BB-2BFA-E24E-82AE-288ADAB701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7507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F7934-A803-614D-B7D5-96394A326413}" type="datetimeFigureOut">
              <a:rPr lang="en-US" smtClean="0"/>
              <a:t>4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742BB-2BFA-E24E-82AE-288ADAB701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721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F7934-A803-614D-B7D5-96394A326413}" type="datetimeFigureOut">
              <a:rPr lang="en-US" smtClean="0"/>
              <a:t>4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742BB-2BFA-E24E-82AE-288ADAB701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01247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6F7934-A803-614D-B7D5-96394A326413}" type="datetimeFigureOut">
              <a:rPr lang="en-US" smtClean="0"/>
              <a:t>4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6742BB-2BFA-E24E-82AE-288ADAB701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4260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xmlns="" id="{98AB87D7-1712-B74D-9C0E-CDDF6FCC092A}"/>
              </a:ext>
            </a:extLst>
          </p:cNvPr>
          <p:cNvGrpSpPr/>
          <p:nvPr/>
        </p:nvGrpSpPr>
        <p:grpSpPr>
          <a:xfrm>
            <a:off x="1093894" y="199596"/>
            <a:ext cx="4508656" cy="2558559"/>
            <a:chOff x="722918" y="1982047"/>
            <a:chExt cx="5659936" cy="3131002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xmlns="" id="{8347B992-D32B-F248-9C3C-7557C5797F1E}"/>
                </a:ext>
              </a:extLst>
            </p:cNvPr>
            <p:cNvGrpSpPr/>
            <p:nvPr/>
          </p:nvGrpSpPr>
          <p:grpSpPr>
            <a:xfrm>
              <a:off x="722918" y="2084120"/>
              <a:ext cx="5659936" cy="3028929"/>
              <a:chOff x="1089601" y="1286973"/>
              <a:chExt cx="5445526" cy="2744804"/>
            </a:xfrm>
          </p:grpSpPr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xmlns="" id="{F5E0C7F5-1C4C-2B48-B891-B22D4207F21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089601" y="1286973"/>
                <a:ext cx="2888510" cy="2744804"/>
              </a:xfrm>
              <a:prstGeom prst="rect">
                <a:avLst/>
              </a:prstGeom>
            </p:spPr>
          </p:pic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xmlns="" id="{9D65138B-D766-9248-8ECF-0EE8B8FF661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746958" y="1322888"/>
                <a:ext cx="2788169" cy="2649454"/>
              </a:xfrm>
              <a:prstGeom prst="rect">
                <a:avLst/>
              </a:prstGeom>
            </p:spPr>
          </p:pic>
        </p:grp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687B28AE-7F4A-5642-A8DC-3B9040F7535C}"/>
                </a:ext>
              </a:extLst>
            </p:cNvPr>
            <p:cNvSpPr txBox="1"/>
            <p:nvPr/>
          </p:nvSpPr>
          <p:spPr>
            <a:xfrm>
              <a:off x="1130891" y="1982047"/>
              <a:ext cx="357368" cy="3766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1324AB9C-57A8-F94F-AC73-12E0181BF03E}"/>
                </a:ext>
              </a:extLst>
            </p:cNvPr>
            <p:cNvSpPr txBox="1"/>
            <p:nvPr/>
          </p:nvSpPr>
          <p:spPr>
            <a:xfrm>
              <a:off x="3805540" y="1989361"/>
              <a:ext cx="394820" cy="3766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xmlns="" id="{AFF3F941-0A81-6E4B-8893-C1AEB641DBF5}"/>
              </a:ext>
            </a:extLst>
          </p:cNvPr>
          <p:cNvGrpSpPr/>
          <p:nvPr/>
        </p:nvGrpSpPr>
        <p:grpSpPr>
          <a:xfrm>
            <a:off x="1092965" y="2652472"/>
            <a:ext cx="4639853" cy="2577819"/>
            <a:chOff x="6034902" y="2109143"/>
            <a:chExt cx="6186468" cy="3437092"/>
          </a:xfrm>
        </p:grpSpPr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xmlns="" id="{0613B30B-0845-1242-B03B-0621D66E0DC2}"/>
                </a:ext>
              </a:extLst>
            </p:cNvPr>
            <p:cNvGrpSpPr/>
            <p:nvPr/>
          </p:nvGrpSpPr>
          <p:grpSpPr>
            <a:xfrm>
              <a:off x="6034902" y="2109143"/>
              <a:ext cx="6186468" cy="3437092"/>
              <a:chOff x="6137114" y="2077059"/>
              <a:chExt cx="6186468" cy="3437092"/>
            </a:xfrm>
          </p:grpSpPr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xmlns="" id="{3E1D3242-08FC-7E42-AE25-F3AC4FE35C3E}"/>
                  </a:ext>
                </a:extLst>
              </p:cNvPr>
              <p:cNvGrpSpPr/>
              <p:nvPr/>
            </p:nvGrpSpPr>
            <p:grpSpPr>
              <a:xfrm>
                <a:off x="6137114" y="2077059"/>
                <a:ext cx="6186468" cy="3437092"/>
                <a:chOff x="3844477" y="2379732"/>
                <a:chExt cx="3276359" cy="1761812"/>
              </a:xfrm>
            </p:grpSpPr>
            <p:pic>
              <p:nvPicPr>
                <p:cNvPr id="26" name="Picture 25">
                  <a:extLst>
                    <a:ext uri="{FF2B5EF4-FFF2-40B4-BE49-F238E27FC236}">
                      <a16:creationId xmlns:a16="http://schemas.microsoft.com/office/drawing/2014/main" xmlns="" id="{02C9FC22-A954-FC4F-AC2D-ACADCAA729B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4137"/>
                <a:stretch/>
              </p:blipFill>
              <p:spPr>
                <a:xfrm>
                  <a:off x="5414290" y="2449904"/>
                  <a:ext cx="1706546" cy="1691640"/>
                </a:xfrm>
                <a:prstGeom prst="rect">
                  <a:avLst/>
                </a:prstGeom>
              </p:spPr>
            </p:pic>
            <p:grpSp>
              <p:nvGrpSpPr>
                <p:cNvPr id="27" name="Group 26">
                  <a:extLst>
                    <a:ext uri="{FF2B5EF4-FFF2-40B4-BE49-F238E27FC236}">
                      <a16:creationId xmlns:a16="http://schemas.microsoft.com/office/drawing/2014/main" xmlns="" id="{D6DABEC8-8BC5-8243-B3A7-9E5E1F29881A}"/>
                    </a:ext>
                  </a:extLst>
                </p:cNvPr>
                <p:cNvGrpSpPr/>
                <p:nvPr/>
              </p:nvGrpSpPr>
              <p:grpSpPr>
                <a:xfrm>
                  <a:off x="3844477" y="2379732"/>
                  <a:ext cx="1910623" cy="1748649"/>
                  <a:chOff x="6245646" y="2005711"/>
                  <a:chExt cx="3396666" cy="3131003"/>
                </a:xfrm>
              </p:grpSpPr>
              <p:pic>
                <p:nvPicPr>
                  <p:cNvPr id="35" name="Picture 34">
                    <a:extLst>
                      <a:ext uri="{FF2B5EF4-FFF2-40B4-BE49-F238E27FC236}">
                        <a16:creationId xmlns:a16="http://schemas.microsoft.com/office/drawing/2014/main" xmlns="" id="{281897D6-849B-1A47-BEA0-18F2380481D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5"/>
                  <a:srcRect r="10805"/>
                  <a:stretch/>
                </p:blipFill>
                <p:spPr>
                  <a:xfrm>
                    <a:off x="6245646" y="2129352"/>
                    <a:ext cx="2721634" cy="3007362"/>
                  </a:xfrm>
                  <a:prstGeom prst="rect">
                    <a:avLst/>
                  </a:prstGeom>
                </p:spPr>
              </p:pic>
              <p:sp>
                <p:nvSpPr>
                  <p:cNvPr id="31" name="TextBox 30">
                    <a:extLst>
                      <a:ext uri="{FF2B5EF4-FFF2-40B4-BE49-F238E27FC236}">
                        <a16:creationId xmlns:a16="http://schemas.microsoft.com/office/drawing/2014/main" xmlns="" id="{451297BF-F3C5-614F-8419-5B0933B728F5}"/>
                      </a:ext>
                    </a:extLst>
                  </p:cNvPr>
                  <p:cNvSpPr txBox="1"/>
                  <p:nvPr/>
                </p:nvSpPr>
                <p:spPr>
                  <a:xfrm>
                    <a:off x="6654776" y="2005711"/>
                    <a:ext cx="394820" cy="37663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</a:p>
                </p:txBody>
              </p:sp>
              <p:sp>
                <p:nvSpPr>
                  <p:cNvPr id="32" name="TextBox 31">
                    <a:extLst>
                      <a:ext uri="{FF2B5EF4-FFF2-40B4-BE49-F238E27FC236}">
                        <a16:creationId xmlns:a16="http://schemas.microsoft.com/office/drawing/2014/main" xmlns="" id="{E014C65A-7861-7A45-80BF-C1CE65C3C736}"/>
                      </a:ext>
                    </a:extLst>
                  </p:cNvPr>
                  <p:cNvSpPr txBox="1"/>
                  <p:nvPr/>
                </p:nvSpPr>
                <p:spPr>
                  <a:xfrm>
                    <a:off x="9247492" y="2005711"/>
                    <a:ext cx="394820" cy="37663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</a:t>
                    </a:r>
                  </a:p>
                </p:txBody>
              </p:sp>
            </p:grpSp>
          </p:grpSp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xmlns="" id="{907863A1-9A65-F449-A440-05D6A0BE6300}"/>
                  </a:ext>
                </a:extLst>
              </p:cNvPr>
              <p:cNvSpPr/>
              <p:nvPr/>
            </p:nvSpPr>
            <p:spPr>
              <a:xfrm>
                <a:off x="6852521" y="5063575"/>
                <a:ext cx="4745921" cy="11229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</p:grp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xmlns="" id="{17D96685-6F37-7A46-9F91-3C9BB55BABC7}"/>
                </a:ext>
              </a:extLst>
            </p:cNvPr>
            <p:cNvSpPr txBox="1"/>
            <p:nvPr/>
          </p:nvSpPr>
          <p:spPr>
            <a:xfrm>
              <a:off x="6549766" y="5083439"/>
              <a:ext cx="774300" cy="410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CD45</a:t>
              </a:r>
            </a:p>
          </p:txBody>
        </p: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xmlns="" id="{66B28EF7-3956-394E-9680-7E48B14B8FC4}"/>
                </a:ext>
              </a:extLst>
            </p:cNvPr>
            <p:cNvCxnSpPr/>
            <p:nvPr/>
          </p:nvCxnSpPr>
          <p:spPr>
            <a:xfrm flipV="1">
              <a:off x="7245535" y="5237327"/>
              <a:ext cx="4250695" cy="1225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60A56FCA-9286-F94D-BB96-40FFC04E0A5E}"/>
              </a:ext>
            </a:extLst>
          </p:cNvPr>
          <p:cNvSpPr txBox="1"/>
          <p:nvPr/>
        </p:nvSpPr>
        <p:spPr>
          <a:xfrm>
            <a:off x="554295" y="5785148"/>
            <a:ext cx="5806748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 Fig. 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ting strategy for whole blood samples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epresentative whol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lood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ample from AERO-infected rat at 7 dpi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(A) SSC-A and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Gating was first done using (B) singlet inclusion, followed by (C) CD45+ gate and (D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size exclusion. 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21698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59</Words>
  <Application>Microsoft Macintosh PowerPoint</Application>
  <PresentationFormat>Letter Paper (8.5x11 in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be, Joseph R</dc:creator>
  <cp:lastModifiedBy>Hartman, Amy Lynn</cp:lastModifiedBy>
  <cp:revision>10</cp:revision>
  <cp:lastPrinted>2019-01-10T21:19:19Z</cp:lastPrinted>
  <dcterms:created xsi:type="dcterms:W3CDTF">2019-01-10T19:03:13Z</dcterms:created>
  <dcterms:modified xsi:type="dcterms:W3CDTF">2019-04-20T00:42:03Z</dcterms:modified>
</cp:coreProperties>
</file>